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0" r:id="rId2"/>
  </p:sldIdLst>
  <p:sldSz cx="6858000" cy="9906000" type="A4"/>
  <p:notesSz cx="6797675" cy="9926638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EEC"/>
    <a:srgbClr val="663300"/>
    <a:srgbClr val="996633"/>
    <a:srgbClr val="F8C1B6"/>
    <a:srgbClr val="2FFFCD"/>
    <a:srgbClr val="FF47FF"/>
    <a:srgbClr val="F03218"/>
    <a:srgbClr val="FFCC00"/>
    <a:srgbClr val="096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820" autoAdjust="0"/>
    <p:restoredTop sz="86407" autoAdjust="0"/>
  </p:normalViewPr>
  <p:slideViewPr>
    <p:cSldViewPr snapToGrid="0">
      <p:cViewPr varScale="1">
        <p:scale>
          <a:sx n="99" d="100"/>
          <a:sy n="99" d="100"/>
        </p:scale>
        <p:origin x="1956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13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275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275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65EB616-CABF-4B7C-8565-3F13A2DBAE3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098549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3B58F2DE-17C5-4142-9F39-686B0848F31E}" type="datetimeFigureOut">
              <a:rPr lang="en-US"/>
              <a:pPr>
                <a:defRPr/>
              </a:pPr>
              <a:t>5/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04DFB875-2F53-4D6C-ADAB-812F19EB2EE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41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9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7B3581-3040-4C47-ADF3-F7D4BDF131E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99709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17908-283F-4A2E-8FCF-7BC83614E92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835667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31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5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B84506-8937-496E-A9A5-506A604EF8F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59298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88204-B65D-423C-82DF-4A8B8B464684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5293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8640E2-38E6-4B95-8168-088FE1B739E8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6159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E9D79-45D0-4CF4-9705-888B56937B2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6732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6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9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9" y="3141666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736B4A-D98C-4FDE-82E5-666406FC6D72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334067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D88AC4-24D4-4E5E-9378-7ED6E2E80DB9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33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83B130-67A1-42C9-9B68-17CCECACC0B3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661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4"/>
            <a:ext cx="2255838" cy="67754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2EAF75-1BEF-4565-B096-D8E8C0F6EE3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1854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49"/>
            <a:ext cx="4114800" cy="11620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3C5CCA-D13F-480E-AAE9-F766CFFA9F86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20478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ext styles</a:t>
            </a:r>
          </a:p>
          <a:p>
            <a:pPr lvl="1"/>
            <a:r>
              <a:rPr lang="en-GB" altLang="zh-CN" smtClean="0"/>
              <a:t>Second level</a:t>
            </a:r>
          </a:p>
          <a:p>
            <a:pPr lvl="2"/>
            <a:r>
              <a:rPr lang="en-GB" altLang="zh-CN" smtClean="0"/>
              <a:t>Third level</a:t>
            </a:r>
          </a:p>
          <a:p>
            <a:pPr lvl="3"/>
            <a:r>
              <a:rPr lang="en-GB" altLang="zh-CN" smtClean="0"/>
              <a:t>Fourth level</a:t>
            </a:r>
          </a:p>
          <a:p>
            <a:pPr lvl="4"/>
            <a:r>
              <a:rPr lang="en-GB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CFB04EDC-854A-47E1-A7BC-53B84277158A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401" y="1844286"/>
            <a:ext cx="2596008" cy="1947007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8829" y="1858349"/>
            <a:ext cx="2574903" cy="1931178"/>
          </a:xfrm>
          <a:prstGeom prst="rect">
            <a:avLst/>
          </a:prstGeom>
        </p:spPr>
      </p:pic>
      <p:sp>
        <p:nvSpPr>
          <p:cNvPr id="35" name="Rectangle 34"/>
          <p:cNvSpPr/>
          <p:nvPr/>
        </p:nvSpPr>
        <p:spPr>
          <a:xfrm>
            <a:off x="362403" y="4280327"/>
            <a:ext cx="6333067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</a:t>
            </a:r>
            <a:r>
              <a:rPr lang="en-GB" sz="11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6.  </a:t>
            </a:r>
            <a:r>
              <a:rPr lang="en-GB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Absence </a:t>
            </a:r>
            <a:r>
              <a:rPr lang="en-US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of 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PD-L1 expression </a:t>
            </a:r>
            <a:r>
              <a:rPr lang="en-US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in 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thyroid MALT </a:t>
            </a:r>
            <a:r>
              <a:rPr lang="en-US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lymphoma.  A representative case shows negative PD-L1 immunostaining in malignant B-cells and most of intact thyroid epithelial cells, but positive staining in epithelial cells involved in </a:t>
            </a:r>
            <a:r>
              <a:rPr lang="en-US" sz="11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lymphoepithelial</a:t>
            </a:r>
            <a:r>
              <a:rPr lang="en-US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 lesions.      </a:t>
            </a:r>
            <a:endParaRPr lang="en-GB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7214992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42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Calibri</vt:lpstr>
      <vt:lpstr>Times New Roman</vt:lpstr>
      <vt:lpstr>Default Design</vt:lpstr>
      <vt:lpstr>PowerPoint Presentation</vt:lpstr>
    </vt:vector>
  </TitlesOfParts>
  <Company>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 Du</dc:creator>
  <cp:lastModifiedBy>Ming Du</cp:lastModifiedBy>
  <cp:revision>574</cp:revision>
  <dcterms:created xsi:type="dcterms:W3CDTF">2009-09-20T11:37:28Z</dcterms:created>
  <dcterms:modified xsi:type="dcterms:W3CDTF">2021-05-05T13:42:16Z</dcterms:modified>
</cp:coreProperties>
</file>